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jpeg" ContentType="image/jpeg"/>
  <Override PartName="/ppt/media/image4.jpeg" ContentType="image/jpeg"/>
  <Override PartName="/ppt/media/image5.png" ContentType="image/png"/>
  <Override PartName="/ppt/media/image6.jpeg" ContentType="image/jpeg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A0F68-7637-4220-B374-3F69B66E45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2C527-DBE5-4408-9B6F-FF1CB662AB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B9AB1-394F-4B38-9000-6AC8A2AA03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F1040-F4C0-4A69-B0B1-7058A72BAB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A9FEB-F1A9-4404-91A2-6F07BFB82C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B0A73-E809-433C-8D61-9F76FD9E75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B1D47-7AD5-4944-8BC0-1614A6D5F7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107C1-71DC-4024-9233-46F195A6CB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D86A5-27EB-4F30-83BB-5164080D68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4D8A8-00E3-49E1-AFFE-3DEC324A94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AEF1C-9F65-483F-81D1-EC476B5588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C220A-F3CB-4E6A-BFB6-7395C5AC6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501FB1-7F77-48EA-B6E9-87A0D1025D0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3.jpeg"/><Relationship Id="rId8" Type="http://schemas.openxmlformats.org/officeDocument/2006/relationships/image" Target="../media/image3.jpeg"/><Relationship Id="rId9" Type="http://schemas.openxmlformats.org/officeDocument/2006/relationships/image" Target="../media/image3.jpeg"/><Relationship Id="rId10" Type="http://schemas.openxmlformats.org/officeDocument/2006/relationships/image" Target="../media/image4.jpeg"/><Relationship Id="rId11" Type="http://schemas.openxmlformats.org/officeDocument/2006/relationships/image" Target="../media/image4.jpeg"/><Relationship Id="rId12" Type="http://schemas.openxmlformats.org/officeDocument/2006/relationships/image" Target="../media/image4.jpeg"/><Relationship Id="rId13" Type="http://schemas.openxmlformats.org/officeDocument/2006/relationships/image" Target="../media/image5.png"/><Relationship Id="rId14" Type="http://schemas.openxmlformats.org/officeDocument/2006/relationships/image" Target="../media/image6.jpeg"/><Relationship Id="rId15" Type="http://schemas.openxmlformats.org/officeDocument/2006/relationships/image" Target="../media/image6.jpeg"/><Relationship Id="rId16" Type="http://schemas.openxmlformats.org/officeDocument/2006/relationships/image" Target="../media/image6.jpeg"/><Relationship Id="rId17" Type="http://schemas.openxmlformats.org/officeDocument/2006/relationships/image" Target="../media/image6.jpeg"/><Relationship Id="rId18" Type="http://schemas.openxmlformats.org/officeDocument/2006/relationships/image" Target="../media/image5.png"/><Relationship Id="rId19" Type="http://schemas.openxmlformats.org/officeDocument/2006/relationships/image" Target="../media/image5.png"/><Relationship Id="rId20" Type="http://schemas.openxmlformats.org/officeDocument/2006/relationships/image" Target="../media/image5.png"/><Relationship Id="rId21" Type="http://schemas.openxmlformats.org/officeDocument/2006/relationships/oleObject" Target="../embeddings/oleObject3.bin"/><Relationship Id="rId22" Type="http://schemas.openxmlformats.org/officeDocument/2006/relationships/image" Target="../media/image7.wmf"/><Relationship Id="rId2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14400" y="820800"/>
            <a:ext cx="4824000" cy="7257600"/>
            <a:chOff x="914400" y="820800"/>
            <a:chExt cx="4824000" cy="7257600"/>
          </a:xfrm>
        </p:grpSpPr>
        <p:graphicFrame>
          <p:nvGraphicFramePr>
            <p:cNvPr id="42" name=""/>
            <p:cNvGraphicFramePr/>
            <p:nvPr/>
          </p:nvGraphicFramePr>
          <p:xfrm>
            <a:off x="1395360" y="3581280"/>
            <a:ext cx="2490840" cy="19256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395360" y="3581280"/>
                      <a:ext cx="2490840" cy="1925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1333440" y="1019160"/>
            <a:ext cx="2590920" cy="1905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333440" y="1019160"/>
                      <a:ext cx="2590920" cy="1905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"/>
            <p:cNvSpPr/>
            <p:nvPr/>
          </p:nvSpPr>
          <p:spPr>
            <a:xfrm>
              <a:off x="1698840" y="2990880"/>
              <a:ext cx="19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500560" y="2882880"/>
              <a:ext cx="38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005560" y="1131840"/>
              <a:ext cx="50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82% / 5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53400" y="112536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6% / 82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005560" y="213048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68% / 11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919080" y="1284120"/>
              <a:ext cx="40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919080" y="2351160"/>
              <a:ext cx="54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ALB/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894680" y="94608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l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113640" y="94608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338280" y="213984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4% / 83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17640" y="825480"/>
              <a:ext cx="3048120" cy="2286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67320" y="82080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839600" y="335268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l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135240" y="335268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692360" y="5594400"/>
              <a:ext cx="19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94080" y="5486400"/>
              <a:ext cx="38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944640" y="3809880"/>
              <a:ext cx="40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944640" y="4876920"/>
              <a:ext cx="54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ALB/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691280" y="3664080"/>
              <a:ext cx="50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82% / 9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926440" y="366408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4% / 75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605600" y="4648320"/>
              <a:ext cx="50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44% / 9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50120" y="464832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3% / 75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914400" y="3295800"/>
              <a:ext cx="3048120" cy="243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973440" y="330840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" name=""/>
            <p:cNvGrpSpPr/>
            <p:nvPr/>
          </p:nvGrpSpPr>
          <p:grpSpPr>
            <a:xfrm>
              <a:off x="3955320" y="3295800"/>
              <a:ext cx="1783080" cy="1218960"/>
              <a:chOff x="3955320" y="3295800"/>
              <a:chExt cx="1783080" cy="1218960"/>
            </a:xfrm>
          </p:grpSpPr>
          <p:pic>
            <p:nvPicPr>
              <p:cNvPr id="71" name="" descr=""/>
              <p:cNvPicPr/>
              <p:nvPr/>
            </p:nvPicPr>
            <p:blipFill>
              <a:blip r:embed="rId5"/>
              <a:srcRect l="6845" t="45280" r="83956" b="31854"/>
              <a:stretch/>
            </p:blipFill>
            <p:spPr>
              <a:xfrm>
                <a:off x="4280040" y="3981600"/>
                <a:ext cx="228600" cy="206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2" name=""/>
              <p:cNvSpPr/>
              <p:nvPr/>
            </p:nvSpPr>
            <p:spPr>
              <a:xfrm>
                <a:off x="4187880" y="40496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955320" y="39369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H="1">
                <a:off x="5286240" y="407052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310720" y="3960720"/>
                <a:ext cx="427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3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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6" name="" descr=""/>
              <p:cNvPicPr/>
              <p:nvPr/>
            </p:nvPicPr>
            <p:blipFill>
              <a:blip r:embed="rId6">
                <a:lum bright="6000"/>
              </a:blip>
              <a:srcRect l="12283" t="44469" r="79792" b="45124"/>
              <a:stretch/>
            </p:blipFill>
            <p:spPr>
              <a:xfrm>
                <a:off x="4280040" y="4210200"/>
                <a:ext cx="228600" cy="152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"/>
              <p:cNvSpPr/>
              <p:nvPr/>
            </p:nvSpPr>
            <p:spPr>
              <a:xfrm>
                <a:off x="5272200" y="4186080"/>
                <a:ext cx="333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8" name="" descr=""/>
              <p:cNvPicPr/>
              <p:nvPr/>
            </p:nvPicPr>
            <p:blipFill>
              <a:blip r:embed="rId7"/>
              <a:srcRect l="30344" t="44227" r="62921" b="31854"/>
              <a:stretch/>
            </p:blipFill>
            <p:spPr>
              <a:xfrm>
                <a:off x="4532400" y="3981600"/>
                <a:ext cx="214200" cy="215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9" name="" descr=""/>
              <p:cNvPicPr/>
              <p:nvPr/>
            </p:nvPicPr>
            <p:blipFill>
              <a:blip r:embed="rId8"/>
              <a:srcRect l="49878" t="35765" r="41593" b="31854"/>
              <a:stretch/>
            </p:blipFill>
            <p:spPr>
              <a:xfrm>
                <a:off x="4772160" y="3981600"/>
                <a:ext cx="228600" cy="215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" descr=""/>
              <p:cNvPicPr/>
              <p:nvPr/>
            </p:nvPicPr>
            <p:blipFill>
              <a:blip r:embed="rId9"/>
              <a:srcRect l="71401" t="35765" r="20632" b="31854"/>
              <a:stretch/>
            </p:blipFill>
            <p:spPr>
              <a:xfrm>
                <a:off x="5019840" y="3981600"/>
                <a:ext cx="228600" cy="215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1" name="" descr=""/>
              <p:cNvPicPr/>
              <p:nvPr/>
            </p:nvPicPr>
            <p:blipFill>
              <a:blip r:embed="rId10">
                <a:lum bright="6000"/>
              </a:blip>
              <a:srcRect l="34156" t="44469" r="60080" b="45124"/>
              <a:stretch/>
            </p:blipFill>
            <p:spPr>
              <a:xfrm>
                <a:off x="4518000" y="4210200"/>
                <a:ext cx="228600" cy="152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2" name="" descr=""/>
              <p:cNvPicPr/>
              <p:nvPr/>
            </p:nvPicPr>
            <p:blipFill>
              <a:blip r:embed="rId11">
                <a:lum bright="6000"/>
              </a:blip>
              <a:srcRect l="52746" t="44469" r="40924" b="45124"/>
              <a:stretch/>
            </p:blipFill>
            <p:spPr>
              <a:xfrm>
                <a:off x="4772160" y="4210200"/>
                <a:ext cx="228600" cy="152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" descr=""/>
              <p:cNvPicPr/>
              <p:nvPr/>
            </p:nvPicPr>
            <p:blipFill>
              <a:blip r:embed="rId12">
                <a:lum bright="6000"/>
              </a:blip>
              <a:srcRect l="71773" t="44469" r="21625" b="45124"/>
              <a:stretch/>
            </p:blipFill>
            <p:spPr>
              <a:xfrm>
                <a:off x="5016600" y="4210200"/>
                <a:ext cx="228600" cy="152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4" name=""/>
              <p:cNvSpPr/>
              <p:nvPr/>
            </p:nvSpPr>
            <p:spPr>
              <a:xfrm rot="16200000">
                <a:off x="4126320" y="365184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rot="16200000">
                <a:off x="4435200" y="372132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299840" y="337176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l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rot="16200000">
                <a:off x="4611960" y="364572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rot="16200000">
                <a:off x="4929120" y="371448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365720" y="35560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790880" y="337176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h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857840" y="35560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016520" y="3295800"/>
                <a:ext cx="1663560" cy="1218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037400" y="330840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"/>
            <p:cNvGrpSpPr/>
            <p:nvPr/>
          </p:nvGrpSpPr>
          <p:grpSpPr>
            <a:xfrm>
              <a:off x="4010040" y="824040"/>
              <a:ext cx="1693440" cy="1218960"/>
              <a:chOff x="4010040" y="824040"/>
              <a:chExt cx="1693440" cy="1218960"/>
            </a:xfrm>
          </p:grpSpPr>
          <p:pic>
            <p:nvPicPr>
              <p:cNvPr id="95" name="" descr=""/>
              <p:cNvPicPr/>
              <p:nvPr/>
            </p:nvPicPr>
            <p:blipFill>
              <a:blip r:embed="rId13"/>
              <a:srcRect l="3597" t="41577" r="87532" b="44634"/>
              <a:stretch/>
            </p:blipFill>
            <p:spPr>
              <a:xfrm>
                <a:off x="4329000" y="1847880"/>
                <a:ext cx="228600" cy="75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6" name=""/>
              <p:cNvSpPr/>
              <p:nvPr/>
            </p:nvSpPr>
            <p:spPr>
              <a:xfrm flipH="1">
                <a:off x="5312880" y="1679400"/>
                <a:ext cx="57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5320080" y="1569960"/>
                <a:ext cx="38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248360" y="1523880"/>
                <a:ext cx="56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248360" y="1733400"/>
                <a:ext cx="56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025880" y="14097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025880" y="16207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5236200" y="1779480"/>
                <a:ext cx="31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03" name="" descr=""/>
              <p:cNvPicPr/>
              <p:nvPr/>
            </p:nvPicPr>
            <p:blipFill>
              <a:blip r:embed="rId14"/>
              <a:srcRect l="7064" t="36469" r="85007" b="33594"/>
              <a:stretch/>
            </p:blipFill>
            <p:spPr>
              <a:xfrm>
                <a:off x="4319640" y="1509480"/>
                <a:ext cx="243000" cy="323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4" name=""/>
              <p:cNvSpPr/>
              <p:nvPr/>
            </p:nvSpPr>
            <p:spPr>
              <a:xfrm>
                <a:off x="4010040" y="824040"/>
                <a:ext cx="1619280" cy="1218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05" name="" descr=""/>
              <p:cNvPicPr/>
              <p:nvPr/>
            </p:nvPicPr>
            <p:blipFill>
              <a:blip r:embed="rId15"/>
              <a:srcRect l="29757" t="37406" r="62861" b="35281"/>
              <a:stretch/>
            </p:blipFill>
            <p:spPr>
              <a:xfrm>
                <a:off x="4575240" y="1509480"/>
                <a:ext cx="216000" cy="317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6" name="" descr=""/>
              <p:cNvPicPr/>
              <p:nvPr/>
            </p:nvPicPr>
            <p:blipFill>
              <a:blip r:embed="rId16"/>
              <a:srcRect l="70994" t="36469" r="21128" b="33906"/>
              <a:stretch/>
            </p:blipFill>
            <p:spPr>
              <a:xfrm>
                <a:off x="5019840" y="1509480"/>
                <a:ext cx="228600" cy="320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7" name="" descr=""/>
              <p:cNvPicPr/>
              <p:nvPr/>
            </p:nvPicPr>
            <p:blipFill>
              <a:blip r:embed="rId17"/>
              <a:srcRect l="50885" t="36469" r="41975" b="33906"/>
              <a:stretch/>
            </p:blipFill>
            <p:spPr>
              <a:xfrm>
                <a:off x="4805280" y="1509480"/>
                <a:ext cx="209520" cy="320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8" name="" descr=""/>
              <p:cNvPicPr/>
              <p:nvPr/>
            </p:nvPicPr>
            <p:blipFill>
              <a:blip r:embed="rId18"/>
              <a:srcRect l="28090" t="37965" r="65642" b="46405"/>
              <a:stretch/>
            </p:blipFill>
            <p:spPr>
              <a:xfrm>
                <a:off x="4572000" y="1846080"/>
                <a:ext cx="216000" cy="75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" descr=""/>
              <p:cNvPicPr/>
              <p:nvPr/>
            </p:nvPicPr>
            <p:blipFill>
              <a:blip r:embed="rId19"/>
              <a:srcRect l="49685" t="37965" r="43243" b="43279"/>
              <a:stretch/>
            </p:blipFill>
            <p:spPr>
              <a:xfrm>
                <a:off x="4802400" y="1846080"/>
                <a:ext cx="209520" cy="75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0" name="" descr=""/>
              <p:cNvPicPr/>
              <p:nvPr/>
            </p:nvPicPr>
            <p:blipFill>
              <a:blip r:embed="rId20"/>
              <a:srcRect l="70742" t="38868" r="21326" b="45050"/>
              <a:stretch/>
            </p:blipFill>
            <p:spPr>
              <a:xfrm>
                <a:off x="5019840" y="1846080"/>
                <a:ext cx="228600" cy="75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1" name=""/>
              <p:cNvSpPr/>
              <p:nvPr/>
            </p:nvSpPr>
            <p:spPr>
              <a:xfrm>
                <a:off x="4030920" y="82548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rot="16200000">
                <a:off x="4153320" y="119880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 rot="16200000">
                <a:off x="4462200" y="126792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4326840" y="91908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l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 rot="16200000">
                <a:off x="4638960" y="119268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rot="16200000">
                <a:off x="4956120" y="126216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392720" y="110340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817880" y="91908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h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884840" y="110340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" name=""/>
            <p:cNvGrpSpPr/>
            <p:nvPr/>
          </p:nvGrpSpPr>
          <p:grpSpPr>
            <a:xfrm>
              <a:off x="914400" y="5919840"/>
              <a:ext cx="2048040" cy="2158560"/>
              <a:chOff x="914400" y="5919840"/>
              <a:chExt cx="2048040" cy="2158560"/>
            </a:xfrm>
          </p:grpSpPr>
          <p:graphicFrame>
            <p:nvGraphicFramePr>
              <p:cNvPr id="121" name=""/>
              <p:cNvGraphicFramePr/>
              <p:nvPr/>
            </p:nvGraphicFramePr>
            <p:xfrm>
              <a:off x="1447920" y="6095880"/>
              <a:ext cx="1338120" cy="1833480"/>
            </p:xfrm>
            <a:graphic>
              <a:graphicData uri="http://schemas.openxmlformats.org/presentationml/2006/ole">
                <p:oleObj r:id="rId21" spid="">
                  <p:embed/>
                  <p:pic>
                    <p:nvPicPr>
                      <p:cNvPr id="122" name="" descr=""/>
                      <p:cNvPicPr/>
                      <p:nvPr/>
                    </p:nvPicPr>
                    <p:blipFill>
                      <a:blip r:embed="rId22"/>
                      <a:stretch/>
                    </p:blipFill>
                    <p:spPr>
                      <a:xfrm>
                        <a:off x="1447920" y="6095880"/>
                        <a:ext cx="1338120" cy="1833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23" name=""/>
              <p:cNvSpPr/>
              <p:nvPr/>
            </p:nvSpPr>
            <p:spPr>
              <a:xfrm>
                <a:off x="1916640" y="7862760"/>
                <a:ext cx="439920" cy="21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2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963360" y="637200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963360" y="729144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914400" y="5919840"/>
                <a:ext cx="2048040" cy="21333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982800" y="5979960"/>
                <a:ext cx="26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338200" y="64357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5%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070000" y="61675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93%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H="1">
                <a:off x="1971720" y="6605640"/>
                <a:ext cx="38088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H="1">
                <a:off x="1952280" y="630072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280960" y="73501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4%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079360" y="70819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95%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H="1">
                <a:off x="1914120" y="7520040"/>
                <a:ext cx="38124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H="1">
                <a:off x="1962000" y="721512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3T19:39:19Z</dcterms:created>
  <dc:creator>Gisela Vaitaitis</dc:creator>
  <dc:description/>
  <dc:language>en-US</dc:language>
  <cp:lastModifiedBy>Gisela Vaitaitis</cp:lastModifiedBy>
  <dcterms:modified xsi:type="dcterms:W3CDTF">2008-03-13T19:40:33Z</dcterms:modified>
  <cp:revision>1</cp:revision>
  <dc:subject/>
  <dc:title>Slide 1</dc:title>
</cp:coreProperties>
</file>